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_rels/slide13.xml.rels" ContentType="application/vnd.openxmlformats-package.relationships+xml"/>
  <Override PartName="/ppt/slides/_rels/slide12.xml.rels" ContentType="application/vnd.openxmlformats-package.relationships+xml"/>
  <Override PartName="/ppt/slides/_rels/slide11.xml.rels" ContentType="application/vnd.openxmlformats-package.relationships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9.xml" ContentType="application/vnd.openxmlformats-officedocument.presentationml.slide+xml"/>
  <Override PartName="/ppt/slides/slide11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7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3.xml" ContentType="application/vnd.openxmlformats-officedocument.presentationml.slide+xml"/>
  <Override PartName="/ppt/slides/slide2.xml" ContentType="application/vnd.openxmlformats-officedocument.presentationml.slide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  <p:sldId id="266" r:id="rId13"/>
    <p:sldId id="267" r:id="rId14"/>
    <p:sldId id="268" r:id="rId15"/>
  </p:sldIdLst>
  <p:sldSz cx="9144000" cy="51450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slide" Target="slides/slide11.xml"/><Relationship Id="rId14" Type="http://schemas.openxmlformats.org/officeDocument/2006/relationships/slide" Target="slides/slide12.xml"/><Relationship Id="rId15" Type="http://schemas.openxmlformats.org/officeDocument/2006/relationships/slide" Target="slides/slide13.xml"/><Relationship Id="rId1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202209-FDF9-463D-A88B-D7CF1C4B514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06280"/>
            <a:ext cx="82296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200240"/>
            <a:ext cx="82296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2973240"/>
            <a:ext cx="82296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62A6EA-0EEC-4C93-8E24-A9F8AE7621A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06280"/>
            <a:ext cx="82296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200240"/>
            <a:ext cx="40158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200240"/>
            <a:ext cx="40158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2973240"/>
            <a:ext cx="40158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2973240"/>
            <a:ext cx="40158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FA5BCD-09C8-4DD8-A459-8ECDE7536764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06280"/>
            <a:ext cx="82296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200240"/>
            <a:ext cx="26496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200240"/>
            <a:ext cx="26496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200240"/>
            <a:ext cx="26496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2973240"/>
            <a:ext cx="26496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2973240"/>
            <a:ext cx="26496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2973240"/>
            <a:ext cx="26496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9846E6A-D6D5-44A4-AEB4-2862BCCE0AF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06280"/>
            <a:ext cx="82296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200240"/>
            <a:ext cx="8229600" cy="33940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4F53DF-6D88-41EC-8DA5-9E813367385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06280"/>
            <a:ext cx="82296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200240"/>
            <a:ext cx="8229600" cy="339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74F521-E667-4037-BA99-F998521AAE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06280"/>
            <a:ext cx="82296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200240"/>
            <a:ext cx="4015800" cy="339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200240"/>
            <a:ext cx="4015800" cy="339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40DA1A-66DC-41AC-8BF0-7EDA21A3828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06280"/>
            <a:ext cx="82296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A256EE-9CEF-4638-B1A5-AC5DA3FB66F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06280"/>
            <a:ext cx="8229600" cy="39762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F50769-9F83-4DA6-B00D-FA995846635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06280"/>
            <a:ext cx="82296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200240"/>
            <a:ext cx="40158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200240"/>
            <a:ext cx="4015800" cy="339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2973240"/>
            <a:ext cx="40158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257454-3625-4AE5-B1CC-32DF7889916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06280"/>
            <a:ext cx="82296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200240"/>
            <a:ext cx="4015800" cy="339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200240"/>
            <a:ext cx="40158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2973240"/>
            <a:ext cx="40158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6C478F-104B-4DF3-B5AC-B871E9C9FC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06280"/>
            <a:ext cx="82296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200240"/>
            <a:ext cx="40158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200240"/>
            <a:ext cx="40158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2973240"/>
            <a:ext cx="8229600" cy="1618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942612-2305-475B-BABF-40FE9D9F440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06280"/>
            <a:ext cx="8229600" cy="857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200240"/>
            <a:ext cx="8229600" cy="33940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82000"/>
          </a:bodyPr>
          <a:p>
            <a:pPr marL="281160" indent="-28116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609120" indent="-23436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937080" indent="-1872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311840" indent="-1872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1686960" indent="-1872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1686960" indent="-1872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1686960" indent="-1872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4766760"/>
            <a:ext cx="2133720" cy="2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4766760"/>
            <a:ext cx="2895840" cy="2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4766760"/>
            <a:ext cx="2133720" cy="2746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8B3530C-6955-4911-871B-75B52D01BDC3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slideLayout" Target="../slideLayouts/slideLayout1.xml"/>
</Relationships>
</file>

<file path=ppt/slides/_rels/slide11.xml.rels><?xml version="1.0" encoding="UTF-8"?>
<Relationships xmlns="http://schemas.openxmlformats.org/package/2006/relationships"><Relationship Id="rId1" Type="http://schemas.openxmlformats.org/officeDocument/2006/relationships/image" Target="../media/image9.png"/><Relationship Id="rId2" Type="http://schemas.openxmlformats.org/officeDocument/2006/relationships/slideLayout" Target="../slideLayouts/slideLayout1.xml"/>
</Relationships>
</file>

<file path=ppt/slides/_rels/slide12.xml.rels><?xml version="1.0" encoding="UTF-8"?>
<Relationships xmlns="http://schemas.openxmlformats.org/package/2006/relationships"><Relationship Id="rId1" Type="http://schemas.openxmlformats.org/officeDocument/2006/relationships/image" Target="../media/image10.png"/><Relationship Id="rId2" Type="http://schemas.openxmlformats.org/officeDocument/2006/relationships/slideLayout" Target="../slideLayouts/slideLayout1.xml"/>
</Relationships>
</file>

<file path=ppt/slides/_rels/slide13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6.png"/><Relationship Id="rId2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image" Target="../media/image7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>
            <a:off x="3059280" y="187200"/>
            <a:ext cx="3095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TextBox 2"/>
          <p:cNvSpPr/>
          <p:nvPr/>
        </p:nvSpPr>
        <p:spPr>
          <a:xfrm>
            <a:off x="1403280" y="627120"/>
            <a:ext cx="712944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Significant KEGG pathways that are closely related to tumor development in human LSCC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Text Box 5"/>
          <p:cNvSpPr/>
          <p:nvPr/>
        </p:nvSpPr>
        <p:spPr>
          <a:xfrm>
            <a:off x="3348000" y="1203480"/>
            <a:ext cx="3008520" cy="2810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1.1 Proteasome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1.2 Glycolysis / Gluconeogenesis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1.3 Fructose and mannose metabolism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1.4 Central carbon metabolism in cancer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1.5 Carbon metabolism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1.6 HIF-1 signaling pathway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1.7 Tight junctio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1.8  Adherens junction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1.9 PI3K-Akt signaling pathway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1.10 Rap1 signaling pathway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spcBef>
                <a:spcPts val="68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1.11 cGMP-PKG signaling pathway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6" name="Picture 2" descr="G:\R_400GO\KEGG Pathways\hsa04520.png"/>
          <p:cNvPicPr/>
          <p:nvPr/>
        </p:nvPicPr>
        <p:blipFill>
          <a:blip r:embed="rId1"/>
          <a:srcRect l="3211" t="3546" r="1563" b="3214"/>
          <a:stretch/>
        </p:blipFill>
        <p:spPr>
          <a:xfrm>
            <a:off x="539640" y="217440"/>
            <a:ext cx="5075280" cy="45864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67" name="Text Box 3"/>
          <p:cNvSpPr/>
          <p:nvPr/>
        </p:nvSpPr>
        <p:spPr>
          <a:xfrm>
            <a:off x="6987600" y="4818240"/>
            <a:ext cx="204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1.8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8" name=""/>
          <p:cNvGraphicFramePr/>
          <p:nvPr/>
        </p:nvGraphicFramePr>
        <p:xfrm>
          <a:off x="5940360" y="274680"/>
          <a:ext cx="2641680" cy="4470480"/>
        </p:xfrm>
        <a:graphic>
          <a:graphicData uri="http://schemas.openxmlformats.org/drawingml/2006/table">
            <a:tbl>
              <a:tblPr/>
              <a:tblGrid>
                <a:gridCol w="609840"/>
                <a:gridCol w="812520"/>
                <a:gridCol w="609840"/>
                <a:gridCol w="609480"/>
              </a:tblGrid>
              <a:tr h="60012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thway nod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tein access numb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odified sit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tio (T/N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2220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tin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24R6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3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2076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GF1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806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0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2220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QGAP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24RC6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9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2076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QGAP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24RC6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6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2040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ho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24R3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2256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ho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24R3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2040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120ct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607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74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2256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120ct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607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67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2040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120ct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607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35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9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2220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120ct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607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4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2076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120ct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607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8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516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c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24R1P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Picture 2" descr="G:\R_400GO\KEGG Pathways\hsa04151.png"/>
          <p:cNvPicPr/>
          <p:nvPr/>
        </p:nvPicPr>
        <p:blipFill>
          <a:blip r:embed="rId1"/>
          <a:srcRect l="2582" t="2989" r="1108" b="3433"/>
          <a:stretch/>
        </p:blipFill>
        <p:spPr>
          <a:xfrm>
            <a:off x="255600" y="403200"/>
            <a:ext cx="5684760" cy="42451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70" name="Text Box 3"/>
          <p:cNvSpPr/>
          <p:nvPr/>
        </p:nvSpPr>
        <p:spPr>
          <a:xfrm>
            <a:off x="6916320" y="4745160"/>
            <a:ext cx="204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1.9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1" name=""/>
          <p:cNvGraphicFramePr/>
          <p:nvPr/>
        </p:nvGraphicFramePr>
        <p:xfrm>
          <a:off x="6084720" y="403200"/>
          <a:ext cx="2743200" cy="4245120"/>
        </p:xfrm>
        <a:graphic>
          <a:graphicData uri="http://schemas.openxmlformats.org/drawingml/2006/table">
            <a:tbl>
              <a:tblPr/>
              <a:tblGrid>
                <a:gridCol w="635040"/>
                <a:gridCol w="876600"/>
                <a:gridCol w="609480"/>
                <a:gridCol w="622080"/>
              </a:tblGrid>
              <a:tr h="66672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thway nod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tein access numb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odified sit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tio (T/N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508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NB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6287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3472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GFI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806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0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652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P2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140VJT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6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508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NB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24R05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508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YK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24R24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58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472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YK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24R24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5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508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SP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24RD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6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652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SP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24RD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9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508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PHA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24QZA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6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472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NG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Q9UBI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3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-/N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508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TGB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555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7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3508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P2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140VJS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588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4-3-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6225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416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NB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632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-/N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560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C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1210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95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-/N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2" name="Picture 2" descr="G:\R_400GO\KEGG Pathways\hsa04015.png"/>
          <p:cNvPicPr/>
          <p:nvPr/>
        </p:nvPicPr>
        <p:blipFill>
          <a:blip r:embed="rId1"/>
          <a:srcRect l="2536" t="4204" r="1699" b="4409"/>
          <a:stretch/>
        </p:blipFill>
        <p:spPr>
          <a:xfrm>
            <a:off x="182520" y="617400"/>
            <a:ext cx="5586480" cy="36496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73" name="Text Box 3"/>
          <p:cNvSpPr/>
          <p:nvPr/>
        </p:nvSpPr>
        <p:spPr>
          <a:xfrm>
            <a:off x="6802920" y="4557600"/>
            <a:ext cx="2134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1.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4" name=""/>
          <p:cNvGraphicFramePr/>
          <p:nvPr/>
        </p:nvGraphicFramePr>
        <p:xfrm>
          <a:off x="6084720" y="617400"/>
          <a:ext cx="2603520" cy="3649680"/>
        </p:xfrm>
        <a:graphic>
          <a:graphicData uri="http://schemas.openxmlformats.org/drawingml/2006/table">
            <a:tbl>
              <a:tblPr/>
              <a:tblGrid>
                <a:gridCol w="609840"/>
                <a:gridCol w="903240"/>
                <a:gridCol w="480960"/>
                <a:gridCol w="609480"/>
              </a:tblGrid>
              <a:tr h="56520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thway nod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tein access numb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odified sit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tio (T/N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NAI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489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4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4128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C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24R1P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36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NAI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875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9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ho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24R3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980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ho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24R3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984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PHA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24QZA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6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TGB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555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7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980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TNND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607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74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72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TNND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607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67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980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TNND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607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35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9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TNND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607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4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9836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TNND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607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8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016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FN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773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9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0772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GF1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806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0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5" name="Picture 2" descr="G:\R_400GO\KEGG Pathways\hsa04022.png"/>
          <p:cNvPicPr/>
          <p:nvPr/>
        </p:nvPicPr>
        <p:blipFill>
          <a:blip r:embed="rId1"/>
          <a:srcRect l="2701" t="3187" r="2414" b="3053"/>
          <a:stretch/>
        </p:blipFill>
        <p:spPr>
          <a:xfrm>
            <a:off x="266760" y="195120"/>
            <a:ext cx="5181480" cy="46483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76" name="Text Box 3"/>
          <p:cNvSpPr/>
          <p:nvPr/>
        </p:nvSpPr>
        <p:spPr>
          <a:xfrm>
            <a:off x="6976080" y="4889520"/>
            <a:ext cx="2134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1.1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77" name=""/>
          <p:cNvGraphicFramePr/>
          <p:nvPr/>
        </p:nvGraphicFramePr>
        <p:xfrm>
          <a:off x="6012000" y="195120"/>
          <a:ext cx="2679480" cy="4648320"/>
        </p:xfrm>
        <a:graphic>
          <a:graphicData uri="http://schemas.openxmlformats.org/drawingml/2006/table">
            <a:tbl>
              <a:tblPr/>
              <a:tblGrid>
                <a:gridCol w="609480"/>
                <a:gridCol w="851040"/>
                <a:gridCol w="609480"/>
                <a:gridCol w="609480"/>
              </a:tblGrid>
              <a:tr h="52704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thway nod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tein access numb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odified sit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tio (T/N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1608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P1A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50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6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1572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P1A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50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44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608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P1A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50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46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2.8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608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P1A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50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66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752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P1A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50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2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572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P2A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S2Z3L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608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TP2B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24R96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572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DAC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2179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608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VDAC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Q9Y27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572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NAI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489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4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608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NAI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875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9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572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ho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24R3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2868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ho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24R3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" name="TextBox 1"/>
          <p:cNvSpPr/>
          <p:nvPr/>
        </p:nvSpPr>
        <p:spPr>
          <a:xfrm>
            <a:off x="900000" y="700200"/>
            <a:ext cx="7775640" cy="3274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100" spc="-1" strike="noStrike">
                <a:solidFill>
                  <a:srgbClr val="000000"/>
                </a:solidFill>
                <a:latin typeface="Arial"/>
              </a:rPr>
              <a:t>NOTE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: (1) In each pathway, the proteins enriched in this research were labeled as red, blue and yellow, respectively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          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(2) Red nodes represents the intensity of  identified ubiquitination modification sites corresponding to one protein is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               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up-regulated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          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(3) Blue nodes represent the intensity of identified ubiquitination modification sites corresponding to one protein is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               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down-regulated.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          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(4) Yellow nodes indicate more than one modification site were identified for these proteins, and the intensity of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                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ubiquitination of the sites were inconsistent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          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           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(5) A arrow (</a:t>
            </a:r>
            <a:r>
              <a:rPr b="1" lang="zh-CN" sz="1100" spc="-1" strike="noStrike">
                <a:solidFill>
                  <a:srgbClr val="000000"/>
                </a:solidFill>
                <a:latin typeface="Arial"/>
              </a:rPr>
              <a:t>→</a:t>
            </a: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) denotes the pathway direction.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5" name="Picture 2" descr="G:\R_400GO\KEGG Pathways\hsa03050.png"/>
          <p:cNvPicPr/>
          <p:nvPr/>
        </p:nvPicPr>
        <p:blipFill>
          <a:blip r:embed="rId1"/>
          <a:srcRect l="685" t="3167" r="2191" b="2917"/>
          <a:stretch/>
        </p:blipFill>
        <p:spPr>
          <a:xfrm>
            <a:off x="119160" y="123840"/>
            <a:ext cx="5965560" cy="45338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6" name="Text Box 3"/>
          <p:cNvSpPr/>
          <p:nvPr/>
        </p:nvSpPr>
        <p:spPr>
          <a:xfrm>
            <a:off x="6732000" y="4745160"/>
            <a:ext cx="204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1.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7" name=""/>
          <p:cNvGraphicFramePr/>
          <p:nvPr/>
        </p:nvGraphicFramePr>
        <p:xfrm>
          <a:off x="6227640" y="123840"/>
          <a:ext cx="2656080" cy="4533840"/>
        </p:xfrm>
        <a:graphic>
          <a:graphicData uri="http://schemas.openxmlformats.org/drawingml/2006/table">
            <a:tbl>
              <a:tblPr/>
              <a:tblGrid>
                <a:gridCol w="567000"/>
                <a:gridCol w="838080"/>
                <a:gridCol w="593640"/>
                <a:gridCol w="657360"/>
              </a:tblGrid>
              <a:tr h="525600"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thway nod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tein access numb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odified sit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tio (T/N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2640"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pn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Q1618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3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ctr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7200" marR="72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44440"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pt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6219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2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6080"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pt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140VK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4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9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25440"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pt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140VK4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37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95200"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pt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140VK4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5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4440"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pt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8K2M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27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84400"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pt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140VJS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34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74320"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pt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140VJS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3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06360"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pt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140VJS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29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3000"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pt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87X2I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4440"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pt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87X2I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32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4440"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pt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87X2I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6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3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4440"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pn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4324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27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44800"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pn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0023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3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3800"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pn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S2Z48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4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200" rIns="7200" tIns="72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200" marR="72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Picture 3" descr="G:\R_400GO\KEGG Pathways\hsa00010.png"/>
          <p:cNvPicPr/>
          <p:nvPr/>
        </p:nvPicPr>
        <p:blipFill>
          <a:blip r:embed="rId1"/>
          <a:srcRect l="4487" t="2839" r="3009" b="3835"/>
          <a:stretch/>
        </p:blipFill>
        <p:spPr>
          <a:xfrm>
            <a:off x="395280" y="123840"/>
            <a:ext cx="4465800" cy="4824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9" name="Text Box 3"/>
          <p:cNvSpPr/>
          <p:nvPr/>
        </p:nvSpPr>
        <p:spPr>
          <a:xfrm>
            <a:off x="7060680" y="4889520"/>
            <a:ext cx="204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1.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0" name=""/>
          <p:cNvGraphicFramePr/>
          <p:nvPr/>
        </p:nvGraphicFramePr>
        <p:xfrm>
          <a:off x="4984920" y="123840"/>
          <a:ext cx="2539800" cy="4824360"/>
        </p:xfrm>
        <a:graphic>
          <a:graphicData uri="http://schemas.openxmlformats.org/drawingml/2006/table">
            <a:tbl>
              <a:tblPr/>
              <a:tblGrid>
                <a:gridCol w="609480"/>
                <a:gridCol w="799920"/>
                <a:gridCol w="584280"/>
                <a:gridCol w="546120"/>
              </a:tblGrid>
              <a:tr h="54432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thway nod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tein access numb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odified sit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tio (T/N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1932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2.1.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24R4F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8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1896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1.2.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40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8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1112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1.2.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40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2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2552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.1.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44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8592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.1.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44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2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896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.1.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44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7296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.1.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44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8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6.9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5892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7.1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3KXY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9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9852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1.1.2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719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30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896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7.2.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055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2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1896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7.1.4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146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2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3192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3.1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6017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6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" name="Picture 4" descr="G:\R_400GO\KEGG Pathways\hsa00051.png"/>
          <p:cNvPicPr/>
          <p:nvPr/>
        </p:nvPicPr>
        <p:blipFill>
          <a:blip r:embed="rId1"/>
          <a:srcRect l="1332" t="3102" r="1662" b="3081"/>
          <a:stretch/>
        </p:blipFill>
        <p:spPr>
          <a:xfrm>
            <a:off x="347760" y="123840"/>
            <a:ext cx="5448240" cy="47163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2" name="Text Box 3"/>
          <p:cNvSpPr/>
          <p:nvPr/>
        </p:nvSpPr>
        <p:spPr>
          <a:xfrm>
            <a:off x="7019280" y="4869000"/>
            <a:ext cx="204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1.3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3" name=""/>
          <p:cNvGraphicFramePr/>
          <p:nvPr/>
        </p:nvGraphicFramePr>
        <p:xfrm>
          <a:off x="5940360" y="123840"/>
          <a:ext cx="2438640" cy="4716360"/>
        </p:xfrm>
        <a:graphic>
          <a:graphicData uri="http://schemas.openxmlformats.org/drawingml/2006/table">
            <a:tbl>
              <a:tblPr/>
              <a:tblGrid>
                <a:gridCol w="609840"/>
                <a:gridCol w="609480"/>
                <a:gridCol w="609480"/>
                <a:gridCol w="609840"/>
              </a:tblGrid>
              <a:tr h="58428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thway nod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tein access numb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odified sit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tio (T/N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5252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1.2.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40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8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45216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1.2.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40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2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58572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.1.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44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60336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.1.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44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2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54792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.1.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44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5216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.2.1.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44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8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6.9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52884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7.1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3KXY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9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50940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3.1.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6017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6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Picture 2" descr="G:\R_400GO\KEGG Pathways\hsa05230.png"/>
          <p:cNvPicPr/>
          <p:nvPr/>
        </p:nvPicPr>
        <p:blipFill>
          <a:blip r:embed="rId1"/>
          <a:srcRect l="1403" t="2755" r="1144" b="2934"/>
          <a:stretch/>
        </p:blipFill>
        <p:spPr>
          <a:xfrm>
            <a:off x="108000" y="411120"/>
            <a:ext cx="6033960" cy="417672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5" name="Text Box 3"/>
          <p:cNvSpPr/>
          <p:nvPr/>
        </p:nvSpPr>
        <p:spPr>
          <a:xfrm>
            <a:off x="6987600" y="4803840"/>
            <a:ext cx="204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1.4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6" name=""/>
          <p:cNvGraphicFramePr/>
          <p:nvPr/>
        </p:nvGraphicFramePr>
        <p:xfrm>
          <a:off x="6372360" y="411120"/>
          <a:ext cx="2438280" cy="4146480"/>
        </p:xfrm>
        <a:graphic>
          <a:graphicData uri="http://schemas.openxmlformats.org/drawingml/2006/table">
            <a:tbl>
              <a:tblPr/>
              <a:tblGrid>
                <a:gridCol w="609480"/>
                <a:gridCol w="830160"/>
                <a:gridCol w="576360"/>
                <a:gridCol w="422280"/>
              </a:tblGrid>
              <a:tr h="55080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thway nod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tein access numb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odified sit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tio (T/N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7008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K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3KXY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9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37152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K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146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2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7772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LC1A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Q1575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7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9356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LC1A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Q1575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36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7.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4784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LUT1/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Q59GX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2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0.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36972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LUT1/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Q59GX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50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43200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LAT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Q0165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63324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CT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24R8U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43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7" name="Picture 2" descr="G:\R_400GO\KEGG Pathways\hsa01200.png"/>
          <p:cNvPicPr/>
          <p:nvPr/>
        </p:nvPicPr>
        <p:blipFill>
          <a:blip r:embed="rId1"/>
          <a:srcRect l="1925" t="1983" r="1256" b="1983"/>
          <a:stretch/>
        </p:blipFill>
        <p:spPr>
          <a:xfrm>
            <a:off x="747720" y="195120"/>
            <a:ext cx="4329000" cy="470088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8" name="Text Box 3"/>
          <p:cNvSpPr/>
          <p:nvPr/>
        </p:nvSpPr>
        <p:spPr>
          <a:xfrm>
            <a:off x="6987600" y="4889520"/>
            <a:ext cx="204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1.5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9" name=""/>
          <p:cNvGraphicFramePr/>
          <p:nvPr/>
        </p:nvGraphicFramePr>
        <p:xfrm>
          <a:off x="5435640" y="195120"/>
          <a:ext cx="2635200" cy="4700880"/>
        </p:xfrm>
        <a:graphic>
          <a:graphicData uri="http://schemas.openxmlformats.org/drawingml/2006/table">
            <a:tbl>
              <a:tblPr/>
              <a:tblGrid>
                <a:gridCol w="600120"/>
                <a:gridCol w="836640"/>
                <a:gridCol w="598320"/>
                <a:gridCol w="600120"/>
              </a:tblGrid>
              <a:tr h="59220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thway nod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tein access numb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odified sit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tio (T/N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560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HGD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431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3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5740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HGD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O431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5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560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G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5220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37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6.5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524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GD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5220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5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740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ALDO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140VK5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3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560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NO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24R4F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8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560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LDO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40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8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704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LDO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407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2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560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PD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44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560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PD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44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2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704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PD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44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560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PD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44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8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6.9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560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K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3KXY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9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740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GK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055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2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560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K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1461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2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676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PI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6017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6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0" name="Picture 2" descr="G:\R_400GO\KEGG Pathways\hsa04066.png"/>
          <p:cNvPicPr/>
          <p:nvPr/>
        </p:nvPicPr>
        <p:blipFill>
          <a:blip r:embed="rId1"/>
          <a:srcRect l="2251" t="3459" r="1504" b="3663"/>
          <a:stretch/>
        </p:blipFill>
        <p:spPr>
          <a:xfrm>
            <a:off x="144360" y="195120"/>
            <a:ext cx="5989680" cy="39672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61" name="Text Box 3"/>
          <p:cNvSpPr/>
          <p:nvPr/>
        </p:nvSpPr>
        <p:spPr>
          <a:xfrm>
            <a:off x="6803640" y="4557600"/>
            <a:ext cx="204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1.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2" name=""/>
          <p:cNvGraphicFramePr/>
          <p:nvPr/>
        </p:nvGraphicFramePr>
        <p:xfrm>
          <a:off x="6300720" y="262080"/>
          <a:ext cx="2629080" cy="3894120"/>
        </p:xfrm>
        <a:graphic>
          <a:graphicData uri="http://schemas.openxmlformats.org/drawingml/2006/table">
            <a:tbl>
              <a:tblPr/>
              <a:tblGrid>
                <a:gridCol w="609840"/>
                <a:gridCol w="799920"/>
                <a:gridCol w="609480"/>
                <a:gridCol w="609840"/>
              </a:tblGrid>
              <a:tr h="52992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thway node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tein access numbe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odified sit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tio (T/N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5740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YBB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S2Z3S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29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5884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LC2A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Q59GX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27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10.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704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SLC2A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Q59GX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50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884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HK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B3KXY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9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704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GF1R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806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03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884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PD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44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704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PD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44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21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2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884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PD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44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.6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704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GAPDH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44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8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16.9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884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NO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24R4F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8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740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LDO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40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1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8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5848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LDO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40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20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3.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68560"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GK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055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21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560" rIns="7560" tIns="756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7560" marR="756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3" name="Picture 2" descr="G:\R_400GO\KEGG Pathways\hsa04530.png"/>
          <p:cNvPicPr/>
          <p:nvPr/>
        </p:nvPicPr>
        <p:blipFill>
          <a:blip r:embed="rId1"/>
          <a:srcRect l="2179" t="2506" r="1703" b="2262"/>
          <a:stretch/>
        </p:blipFill>
        <p:spPr>
          <a:xfrm>
            <a:off x="220680" y="123840"/>
            <a:ext cx="4983120" cy="473220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64" name="Text Box 3"/>
          <p:cNvSpPr/>
          <p:nvPr/>
        </p:nvSpPr>
        <p:spPr>
          <a:xfrm>
            <a:off x="7019280" y="4856040"/>
            <a:ext cx="204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Supplementary Figure 1.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5" name=""/>
          <p:cNvGraphicFramePr/>
          <p:nvPr/>
        </p:nvGraphicFramePr>
        <p:xfrm>
          <a:off x="5651640" y="123840"/>
          <a:ext cx="2736720" cy="4705200"/>
        </p:xfrm>
        <a:graphic>
          <a:graphicData uri="http://schemas.openxmlformats.org/drawingml/2006/table">
            <a:tbl>
              <a:tblPr/>
              <a:tblGrid>
                <a:gridCol w="650880"/>
                <a:gridCol w="933480"/>
                <a:gridCol w="527040"/>
                <a:gridCol w="625320"/>
              </a:tblGrid>
              <a:tr h="50796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athway node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rotein access number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odified sit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atio (T/N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 w="93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108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ub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6836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30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 w="576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18072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ub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6836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33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9.3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ub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6836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33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21.8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ub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6836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32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ub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6836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9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7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72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ub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6836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6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4.9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Interg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0555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7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R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2603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5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-/N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928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R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2603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36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ERM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2603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6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1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072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CN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1200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P2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140VJT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6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900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ctin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24R69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31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900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yos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355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6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928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ho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24R3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1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900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Rho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24R32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3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64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P2A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140VJS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2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8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yos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24QZJ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38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laud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5685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23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-/N+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Claud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P5685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25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7928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yos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24R1N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679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108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yos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24R1N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14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T+/N-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188640"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Myosin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A0A024R1N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K972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5400" rIns="5400" tIns="5400" bIns="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5.4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5400" marR="54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93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0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8-11-07T13:31:16Z</dcterms:created>
  <dc:creator>sanshuilong</dc:creator>
  <dc:description/>
  <dc:language>en-US</dc:language>
  <cp:lastModifiedBy>MC SYSTEM</cp:lastModifiedBy>
  <dcterms:modified xsi:type="dcterms:W3CDTF">2019-12-03T07:00:20Z</dcterms:modified>
  <cp:revision>82</cp:revision>
  <dc:subject/>
  <dc:title>PowerPoint 演示文稿</dc:title>
</cp:coreProperties>
</file>